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6EAD13-631C-4928-A36C-07DB2F84F59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24C4E1-D1CA-43D5-A189-95E8149D88C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5FF1A6-7A91-4FB4-94C1-5AD0E94AE86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27557A-FC8A-4B9A-B17F-D233AAF90B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F225C0-19B7-4468-AF65-4C82A939A7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22E9E6-8AF7-44BA-8C11-95A906E921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61F7FF-0EB2-4073-B58C-D105203029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C4D93A-4B9E-45FF-9717-73C55CA87D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DEA2A6-1D6B-4AEB-9D38-06A8319789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64A65D-F898-437E-9495-003CA0D343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36544A-E755-494F-8BFB-6E839A1C10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5AB299-DC09-4E84-911E-F2AE56EF3B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03F4DF-3AEC-4943-88DE-F38C3FD8C6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C18B1-8DF8-4E5D-A32D-8720DA5C58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25EA65B-AC6C-40CE-B03F-A2FE6BEB3C30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A3EC38-3304-4538-94DD-5351EB4BED0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914400" y="1338120"/>
          <a:ext cx="7010280" cy="5007240"/>
        </p:xfrm>
        <a:graphic>
          <a:graphicData uri="http://schemas.openxmlformats.org/drawingml/2006/table">
            <a:tbl>
              <a:tblPr/>
              <a:tblGrid>
                <a:gridCol w="941400"/>
                <a:gridCol w="2548080"/>
                <a:gridCol w="2357280"/>
                <a:gridCol w="1163520"/>
              </a:tblGrid>
              <a:tr h="2653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T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 PRIM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 PRIM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ODUCT SIZE (BP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7delA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GCTCTTCGCGTTGAAGAAG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CTAGTATGTAAGGTCAATTCTGTT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16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5ins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GCTCTTCGCGTTGAAGAAG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CTAGTATGTAAGGTCAATTCTGTT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VS4-1G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GCAGTTGTGAGATTATCTTTTCA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ACACTGTGAAGGCCCTTTC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1delA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CCTACCCTGCTAGTCTGGA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GTGTTTCCTGGGTTATGAAG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61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CATGCTGAAACTTCTCAAC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GTGGTTGCTTCCAACCTA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63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CATGCTGAAACTTCTCAAC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GTGGTTGCTTCCAACCTA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88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37del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GCTTAGCAAGGAGCCAACA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GAGCATGGCAGTTTCTGC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94del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CTAGAGATACTGAAGATGTTCCTTG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GTCCAATACATCAGCTACTTTG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00delA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AAGGTTTCAAAGCGCCAGT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GGCTTGATATTAGACTCATTCTTTC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908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AAGGTTTCAAAGCGCCAGT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GGCTTGATATTAGACTCATTCTTTC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148delC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AATCTGCTAGAGGAAAACTTTGAG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TACGGCTAATTGTGCTCACTG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450del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GTTTTGCAACCTGAGGTCT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CATGACTACTTCCCATAGGC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604del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TTCTGAGACACCTGATGACC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GGGTGAAAGGGCTAGGACT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88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68delAGins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TTCTGAGACACCTGATGACC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GGGTGAAAGGGCTAGGACT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46ins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CATTTGGCTCAGGGTTACC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GGTGCTATGCCTAGTAGACT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Q1323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CAGTGCAGTGAATTGGAAGAC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TCCAAGCCCGTTCCTCTTTC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1373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CAGCAAGTTGCAGCGTTTA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CACACACACACACGCTT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1443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AGCCAGCCTTCTAACAGCT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AGAAGGAGATAAAGGGGAAG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Q1458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CTGAATTATCACTATCAGAACAAA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GCCTTCTGGATTCTGGCTT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88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1495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CCTTTCTGCTGACAAGTTT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ATGTCAGATACCACAGCATCT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1708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TTTTCAACTTCTAATCCTTTGAGTG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TGTTAAAGGGAGGAGGGGA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385ins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TGGTCAATGGAAGAAACCAC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AAAATGAAGCGGCCCATCT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589del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GGACCCTGGAGTCGATTGA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GTATCAGGTAGGTGTCCA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609del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GGACCCTGGAGTCGATTGA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GTATCAGGTAGGTGTCCA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5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1835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GGACCCTGGAGTCGATTGA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GTATCAGGTAGGTGTCCA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321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GCAAACAGCCTGGCTTAG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TCTCTCACACAGGGGATCA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580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713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CAACTGGAGCCAAGAAGAG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TTTTCTTCTCTTGGAAGGCTAG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16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953delGTAins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GGCTTTCCTGTGGTTGGT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GTTTCGTTGCCTCTGAACT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16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154del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GAAAGCCAGGGAGTTGGTC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ATAAATAGACTGGGGCAAACACAA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Y1463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ATTTGTTTTCTCATTCCATTTAAAGCA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TCTTACCTTTCCACTCCTGGTTC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6160"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454del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AGGGCCTGGGTTAAGTAT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AGGGCACCCAATACTTACTG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8280" marR="82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TextBox 2"/>
          <p:cNvSpPr/>
          <p:nvPr/>
        </p:nvSpPr>
        <p:spPr>
          <a:xfrm>
            <a:off x="533520" y="533520"/>
            <a:ext cx="78483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1:  Sequences of primers used to amplify region surrounding each mutation analyzed in the study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4T23:16:07Z</dcterms:created>
  <dc:creator>alexander miron</dc:creator>
  <dc:description/>
  <dc:language>en-US</dc:language>
  <cp:lastModifiedBy>MIRON</cp:lastModifiedBy>
  <cp:lastPrinted>2010-05-04T17:17:18Z</cp:lastPrinted>
  <dcterms:modified xsi:type="dcterms:W3CDTF">2010-11-12T14:23:51Z</dcterms:modified>
  <cp:revision>14</cp:revision>
  <dc:subject/>
  <dc:title>PowerPoint Presentation</dc:title>
</cp:coreProperties>
</file>